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EBF5"/>
    <a:srgbClr val="CFD5EA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19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9E7A74-A521-4AAF-B83B-DB112255560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AAE348-B657-4F04-8B6B-9491B8DD51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52204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AAE348-B657-4F04-8B6B-9491B8DD518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96487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019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188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938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387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265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5780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1027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318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1131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6545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5386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926AD9-AAD8-4521-9570-E9EB547DCAD8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5E3AFA-A064-427F-9B25-5783C38C74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064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EB85E77-04D6-0E02-4ECC-DEEA4B763E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5713562"/>
              </p:ext>
            </p:extLst>
          </p:nvPr>
        </p:nvGraphicFramePr>
        <p:xfrm>
          <a:off x="747704" y="1128686"/>
          <a:ext cx="5328000" cy="7045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04261">
                  <a:extLst>
                    <a:ext uri="{9D8B030D-6E8A-4147-A177-3AD203B41FA5}">
                      <a16:colId xmlns:a16="http://schemas.microsoft.com/office/drawing/2014/main" val="3346788916"/>
                    </a:ext>
                  </a:extLst>
                </a:gridCol>
                <a:gridCol w="1359739">
                  <a:extLst>
                    <a:ext uri="{9D8B030D-6E8A-4147-A177-3AD203B41FA5}">
                      <a16:colId xmlns:a16="http://schemas.microsoft.com/office/drawing/2014/main" val="2801631884"/>
                    </a:ext>
                  </a:extLst>
                </a:gridCol>
                <a:gridCol w="1332000">
                  <a:extLst>
                    <a:ext uri="{9D8B030D-6E8A-4147-A177-3AD203B41FA5}">
                      <a16:colId xmlns:a16="http://schemas.microsoft.com/office/drawing/2014/main" val="1985588291"/>
                    </a:ext>
                  </a:extLst>
                </a:gridCol>
                <a:gridCol w="1332000">
                  <a:extLst>
                    <a:ext uri="{9D8B030D-6E8A-4147-A177-3AD203B41FA5}">
                      <a16:colId xmlns:a16="http://schemas.microsoft.com/office/drawing/2014/main" val="422858380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egment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err="1"/>
                        <a:t>ATTRwt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err="1"/>
                        <a:t>ATTRv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44547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b="1" dirty="0"/>
                        <a:t>Base</a:t>
                      </a:r>
                      <a:endParaRPr kumimoji="1" lang="ja-JP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0±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0; 3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83950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9±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9; 47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23857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0±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4; 4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63970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6±10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1; 4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27298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4±1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1; 47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31717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8±10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9; 3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87248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b="1" dirty="0"/>
                        <a:t>Mid-ventricle</a:t>
                      </a:r>
                      <a:endParaRPr kumimoji="1" lang="ja-JP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4±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7; 37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77868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1±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2; 42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34887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5±1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6; 44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8565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8±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5; 3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24737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2±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7; 37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76086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0±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2; 3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096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b="1" dirty="0"/>
                        <a:t>Apex</a:t>
                      </a:r>
                      <a:endParaRPr kumimoji="1" lang="ja-JP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3±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5; 3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97834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6±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9; 4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30609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9±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2; 4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77948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4±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9; 40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88524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2±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6; 39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72740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3±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7; 38</a:t>
                      </a:r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9065845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1CBEC99-AF33-505A-C0CE-539DEDABDCE4}"/>
              </a:ext>
            </a:extLst>
          </p:cNvPr>
          <p:cNvSpPr txBox="1"/>
          <p:nvPr/>
        </p:nvSpPr>
        <p:spPr>
          <a:xfrm>
            <a:off x="747702" y="8367717"/>
            <a:ext cx="532800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mean (%) </a:t>
            </a:r>
            <a:r>
              <a:rPr kumimoji="1" lang="en-US" altLang="ja-JP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± standard deviation for </a:t>
            </a:r>
            <a:r>
              <a:rPr kumimoji="1" lang="en-US" altLang="ja-JP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TRwt</a:t>
            </a:r>
            <a:r>
              <a:rPr kumimoji="1" lang="en-US" altLang="ja-JP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n=38) and as absolute value (%) for </a:t>
            </a:r>
            <a:r>
              <a:rPr kumimoji="1" lang="en-US" altLang="ja-JP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TRv</a:t>
            </a:r>
            <a:r>
              <a:rPr kumimoji="1" lang="ja-JP" alt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eterozygous c.424G&gt;A p.Val142Ile;</a:t>
            </a: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eterozygous c.148G&gt;A p.Val50Met</a:t>
            </a:r>
            <a:r>
              <a:rPr kumimoji="1" lang="en-US" altLang="ja-JP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09C2C04-D6EB-5B95-FB00-7BAF75F7188D}"/>
              </a:ext>
            </a:extLst>
          </p:cNvPr>
          <p:cNvSpPr txBox="1"/>
          <p:nvPr/>
        </p:nvSpPr>
        <p:spPr>
          <a:xfrm>
            <a:off x="3905250" y="47618"/>
            <a:ext cx="28230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Table 3. Tsuruda T, et al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2CEB4C1-641D-D9F4-2B78-A17F28581C05}"/>
              </a:ext>
            </a:extLst>
          </p:cNvPr>
          <p:cNvSpPr txBox="1"/>
          <p:nvPr/>
        </p:nvSpPr>
        <p:spPr>
          <a:xfrm>
            <a:off x="962977" y="581018"/>
            <a:ext cx="49126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omparison of ECV between </a:t>
            </a:r>
            <a:r>
              <a:rPr kumimoji="1"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TTRwt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kumimoji="1"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TTRv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999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</TotalTime>
  <Words>158</Words>
  <Application>Microsoft Office PowerPoint</Application>
  <PresentationFormat>ワイド画面</PresentationFormat>
  <Paragraphs>6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敏博 鶴田</dc:creator>
  <cp:lastModifiedBy>敏博 鶴田</cp:lastModifiedBy>
  <cp:revision>40</cp:revision>
  <dcterms:created xsi:type="dcterms:W3CDTF">2024-08-14T23:23:01Z</dcterms:created>
  <dcterms:modified xsi:type="dcterms:W3CDTF">2024-08-21T02:26:55Z</dcterms:modified>
</cp:coreProperties>
</file>